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1045" r:id="rId2"/>
    <p:sldId id="1046" r:id="rId3"/>
  </p:sldIdLst>
  <p:sldSz cx="6858000" cy="9144000" type="screen4x3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B4493BB-9633-FD7E-0760-CF95CFE8B0BC}" name="大平　真裕" initials="" userId="S::mohira@hiroshima-u.ac.jp::6f1e3879-96b9-4dd9-bb58-b31ff753d7e8" providerId="AD"/>
  <p188:author id="{697C4EC2-06AA-1FFD-531A-4CC55D91A564}" name="今岡　洸輝" initials="" userId="S::d214834@hiroshima-u.ac.jp::0d6b482a-ae80-45db-a57a-3422aa6b3544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大平　真裕" initials="大平　真裕" lastIdx="13" clrIdx="0">
    <p:extLst>
      <p:ext uri="{19B8F6BF-5375-455C-9EA6-DF929625EA0E}">
        <p15:presenceInfo xmlns:p15="http://schemas.microsoft.com/office/powerpoint/2012/main" userId="大平　真裕" providerId="None"/>
      </p:ext>
    </p:extLst>
  </p:cmAuthor>
  <p:cmAuthor id="2" name="今岡 祐輝" initials="今岡" lastIdx="2" clrIdx="1">
    <p:extLst>
      <p:ext uri="{19B8F6BF-5375-455C-9EA6-DF929625EA0E}">
        <p15:presenceInfo xmlns:p15="http://schemas.microsoft.com/office/powerpoint/2012/main" userId="1ee950519b3a7e3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CE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752" autoAdjust="0"/>
    <p:restoredTop sz="95177" autoAdjust="0"/>
  </p:normalViewPr>
  <p:slideViewPr>
    <p:cSldViewPr snapToGrid="0">
      <p:cViewPr>
        <p:scale>
          <a:sx n="131" d="100"/>
          <a:sy n="131" d="100"/>
        </p:scale>
        <p:origin x="1600" y="-152"/>
      </p:cViewPr>
      <p:guideLst>
        <p:guide orient="horz" pos="2880"/>
        <p:guide pos="2160"/>
      </p:guideLst>
    </p:cSldViewPr>
  </p:slideViewPr>
  <p:notesTextViewPr>
    <p:cViewPr>
      <p:scale>
        <a:sx n="40" d="100"/>
        <a:sy n="4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8/10/relationships/authors" Target="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AFF16A-FCBD-44F2-A6EC-A1D8DD186573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03688" y="850900"/>
            <a:ext cx="1719262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2201" y="3271103"/>
            <a:ext cx="7942238" cy="267645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1696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6184C8-CA9E-4AEC-814E-D40E755B1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4389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6184C8-CA9E-4AEC-814E-D40E755B1D50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06049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648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044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3060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771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95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8433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688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726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9878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296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9775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37AF87-EA40-4314-9E43-019737F8FB2A}" type="datetimeFigureOut">
              <a:rPr kumimoji="1" lang="ja-JP" altLang="en-US" smtClean="0"/>
              <a:t>2025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A11F69-0C6F-4CBB-8F97-E4AF0187E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8345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598CB3C2-746A-CE80-7DD6-70ECC4867C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7472" y="1061155"/>
            <a:ext cx="4927600" cy="22606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5180BE2-131D-3406-D97B-117FACFF0711}"/>
              </a:ext>
            </a:extLst>
          </p:cNvPr>
          <p:cNvSpPr txBox="1"/>
          <p:nvPr/>
        </p:nvSpPr>
        <p:spPr>
          <a:xfrm rot="16200000">
            <a:off x="-204744" y="2052955"/>
            <a:ext cx="18662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recurrence (%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CD72D75-D482-9D13-25D3-41CA85A842E5}"/>
              </a:ext>
            </a:extLst>
          </p:cNvPr>
          <p:cNvSpPr txBox="1"/>
          <p:nvPr/>
        </p:nvSpPr>
        <p:spPr>
          <a:xfrm>
            <a:off x="1821412" y="3267169"/>
            <a:ext cx="1226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rative month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CFD6B56-D718-25CF-5859-E1FD66622603}"/>
              </a:ext>
            </a:extLst>
          </p:cNvPr>
          <p:cNvSpPr txBox="1"/>
          <p:nvPr/>
        </p:nvSpPr>
        <p:spPr>
          <a:xfrm>
            <a:off x="270933" y="278376"/>
            <a:ext cx="34318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</a:rPr>
              <a:t>Supplemental Figure 1</a:t>
            </a:r>
            <a:r>
              <a:rPr lang="ja-JP" altLang="ja-JP">
                <a:effectLst/>
              </a:rPr>
              <a:t> </a:t>
            </a:r>
            <a:endParaRPr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BEB9F26-2C17-B32D-7197-4CA1009D76C2}"/>
              </a:ext>
            </a:extLst>
          </p:cNvPr>
          <p:cNvSpPr txBox="1"/>
          <p:nvPr/>
        </p:nvSpPr>
        <p:spPr>
          <a:xfrm>
            <a:off x="294161" y="3932393"/>
            <a:ext cx="619609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 1. The effect of each preoperative interventions for IO on liver metastasis</a:t>
            </a:r>
          </a:p>
          <a:p>
            <a:endParaRPr kumimoji="1" lang="en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e were no statistically significant differences in the incidence of liver metastasis between any of the intervention subgroups and the non-IO group.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19369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F3F2072-51BD-B1AE-39F6-26D2F7D343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CEFAF6AF-9275-EEA1-BBA2-0B3812136FB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7513" b="67699"/>
          <a:stretch>
            <a:fillRect/>
          </a:stretch>
        </p:blipFill>
        <p:spPr>
          <a:xfrm>
            <a:off x="2158298" y="1335373"/>
            <a:ext cx="987300" cy="691997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7396EBAE-99C6-9E04-47FA-89225AF963A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7254" b="67699"/>
          <a:stretch>
            <a:fillRect/>
          </a:stretch>
        </p:blipFill>
        <p:spPr>
          <a:xfrm>
            <a:off x="4847017" y="1335372"/>
            <a:ext cx="1015489" cy="691997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8E27AF8E-6EF1-D7EB-DB01-1DAB5099C6F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40319"/>
          <a:stretch>
            <a:fillRect/>
          </a:stretch>
        </p:blipFill>
        <p:spPr>
          <a:xfrm>
            <a:off x="923445" y="960775"/>
            <a:ext cx="1364087" cy="2235574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23DF3489-E232-52FD-EC93-6F76F84132AF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r="44847"/>
          <a:stretch>
            <a:fillRect/>
          </a:stretch>
        </p:blipFill>
        <p:spPr>
          <a:xfrm>
            <a:off x="3588701" y="1131328"/>
            <a:ext cx="1258316" cy="2065021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4426817-2966-7D0D-03FD-59C89CEDBF28}"/>
              </a:ext>
            </a:extLst>
          </p:cNvPr>
          <p:cNvSpPr txBox="1"/>
          <p:nvPr/>
        </p:nvSpPr>
        <p:spPr>
          <a:xfrm rot="16200000">
            <a:off x="-278442" y="1966507"/>
            <a:ext cx="22288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of TRAIL expression on liver NK cells</a:t>
            </a:r>
            <a:endParaRPr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2B101C0-75EC-3BD2-1847-29E7B4129D09}"/>
              </a:ext>
            </a:extLst>
          </p:cNvPr>
          <p:cNvSpPr txBox="1"/>
          <p:nvPr/>
        </p:nvSpPr>
        <p:spPr>
          <a:xfrm rot="16200000">
            <a:off x="2474275" y="1966509"/>
            <a:ext cx="22288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of TRAIL expression on liver NK cells</a:t>
            </a:r>
            <a:endParaRPr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1ED453C-49DA-A8AE-46B9-24C6C75993D1}"/>
              </a:ext>
            </a:extLst>
          </p:cNvPr>
          <p:cNvSpPr txBox="1"/>
          <p:nvPr/>
        </p:nvSpPr>
        <p:spPr>
          <a:xfrm>
            <a:off x="270933" y="278376"/>
            <a:ext cx="34318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</a:rPr>
              <a:t>Supplemental Figure 2</a:t>
            </a:r>
            <a:r>
              <a:rPr lang="ja-JP" altLang="ja-JP">
                <a:effectLst/>
              </a:rPr>
              <a:t> </a:t>
            </a:r>
            <a:endParaRPr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F13457F-79A6-7804-8EC5-0316800E420F}"/>
              </a:ext>
            </a:extLst>
          </p:cNvPr>
          <p:cNvSpPr txBox="1"/>
          <p:nvPr/>
        </p:nvSpPr>
        <p:spPr>
          <a:xfrm>
            <a:off x="363040" y="750530"/>
            <a:ext cx="36740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9875D49-D6F7-0758-BCAF-118DDBD81CD8}"/>
              </a:ext>
            </a:extLst>
          </p:cNvPr>
          <p:cNvSpPr txBox="1"/>
          <p:nvPr/>
        </p:nvSpPr>
        <p:spPr>
          <a:xfrm>
            <a:off x="3145598" y="750530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C4103C0-5FA1-FFBC-5C35-E4E3E661F63F}"/>
              </a:ext>
            </a:extLst>
          </p:cNvPr>
          <p:cNvSpPr txBox="1"/>
          <p:nvPr/>
        </p:nvSpPr>
        <p:spPr>
          <a:xfrm>
            <a:off x="270933" y="3570947"/>
            <a:ext cx="619609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 2. The functional role of such cytokines as IL‐1</a:t>
            </a:r>
            <a:r>
              <a:rPr kumimoji="1" lang="el-GR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</a:t>
            </a:r>
            <a:r>
              <a:rPr kumimoji="1"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L‐6 in liver NK cells </a:t>
            </a:r>
          </a:p>
          <a:p>
            <a:endParaRPr kumimoji="1" lang="en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AutoNum type="alphaUcParenR"/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mononuclear cells (LMNCs) were cultured in the presence of recombinant IL-6 (0, 10, or 100 ng/mL) for 4 hours. The percentage of TRAIL expression in liver NK cell remained unchanged.</a:t>
            </a:r>
          </a:p>
          <a:p>
            <a:pPr marL="228600" indent="-228600">
              <a:buAutoNum type="alphaUcParenR"/>
            </a:pP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Tx/>
              <a:buAutoNum type="alphaUcParenR"/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MNCs were cultured in the presence of recombinant IL-1β (0, 10, or 100 ng/mL) for 4 hours. The percentage of TRAIL expression in liver NK cell remained unchanged.</a:t>
            </a:r>
          </a:p>
        </p:txBody>
      </p:sp>
    </p:spTree>
    <p:extLst>
      <p:ext uri="{BB962C8B-B14F-4D97-AF65-F5344CB8AC3E}">
        <p14:creationId xmlns:p14="http://schemas.microsoft.com/office/powerpoint/2010/main" val="546047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0930</TotalTime>
  <Words>171</Words>
  <Application>Microsoft Macintosh PowerPoint</Application>
  <PresentationFormat>画面に合わせる (4:3)</PresentationFormat>
  <Paragraphs>17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今岡 祐輝</dc:creator>
  <cp:lastModifiedBy>今岡　洸輝</cp:lastModifiedBy>
  <cp:revision>558</cp:revision>
  <cp:lastPrinted>2025-01-08T01:26:35Z</cp:lastPrinted>
  <dcterms:created xsi:type="dcterms:W3CDTF">2020-05-17T01:09:06Z</dcterms:created>
  <dcterms:modified xsi:type="dcterms:W3CDTF">2025-12-15T12:29:25Z</dcterms:modified>
</cp:coreProperties>
</file>